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DABE46A-A046-45F1-97F1-C271E17FE932}" v="1" dt="2025-11-21T17:30:49.80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055" autoAdjust="0"/>
    <p:restoredTop sz="94660"/>
  </p:normalViewPr>
  <p:slideViewPr>
    <p:cSldViewPr snapToGrid="0">
      <p:cViewPr varScale="1">
        <p:scale>
          <a:sx n="43" d="100"/>
          <a:sy n="43" d="100"/>
        </p:scale>
        <p:origin x="54" y="5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eghan Moran" userId="30256bc4-a161-4226-a2d6-4e8766bd09d0" providerId="ADAL" clId="{8B0668C6-C7D0-4AFB-9B8E-773148CE68EF}"/>
    <pc:docChg chg="addSld delSld modSld">
      <pc:chgData name="Meghan Moran" userId="30256bc4-a161-4226-a2d6-4e8766bd09d0" providerId="ADAL" clId="{8B0668C6-C7D0-4AFB-9B8E-773148CE68EF}" dt="2025-11-21T17:30:51.582" v="1" actId="47"/>
      <pc:docMkLst>
        <pc:docMk/>
      </pc:docMkLst>
      <pc:sldChg chg="add">
        <pc:chgData name="Meghan Moran" userId="30256bc4-a161-4226-a2d6-4e8766bd09d0" providerId="ADAL" clId="{8B0668C6-C7D0-4AFB-9B8E-773148CE68EF}" dt="2025-11-21T17:30:49.806" v="0"/>
        <pc:sldMkLst>
          <pc:docMk/>
          <pc:sldMk cId="3927049046" sldId="368"/>
        </pc:sldMkLst>
      </pc:sldChg>
      <pc:sldChg chg="del">
        <pc:chgData name="Meghan Moran" userId="30256bc4-a161-4226-a2d6-4e8766bd09d0" providerId="ADAL" clId="{8B0668C6-C7D0-4AFB-9B8E-773148CE68EF}" dt="2025-11-21T17:30:51.582" v="1" actId="47"/>
        <pc:sldMkLst>
          <pc:docMk/>
          <pc:sldMk cId="1329570729" sldId="369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2DC337-203F-6ACA-81AC-A8CD27A5AE7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99D7B5D-55B0-0F5B-6BA0-DC90372DD49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F04F32-11AA-CBE5-2813-45379BA1F0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299BDA-A4D5-5426-1C32-74827FEEF9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B5029E-681C-D8EA-A9CB-183241D8F5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9010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3EB47E-F2C1-413F-B074-279E0D348F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7D872DB-08DE-46C0-9BE7-C9EA6F70CF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F2B9D5-E42C-8729-D31B-A4C4FFFC2B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023C39-0265-A664-15E0-F0096A2F59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B05800-E7E3-DEA3-F080-8507E4D9CF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35469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94666AB-3A2A-CAEC-CCB0-2D71536B3C2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E2294C-2D59-A5D6-2BB4-5F224E22D2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8C372F-A7A7-E7B0-F777-9CFD148559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BE6756-259C-5BDB-275F-725DCB4E8B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152E30-8BB8-6455-1F33-5535A5DF3C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89010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7A5150-CAE5-4302-4470-A41AD735A5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25F923-B478-8748-7F7D-2781A5F69C2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D437E4-8C26-5284-E89D-FACD8C4318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B7BBD2-44EF-10AD-EA54-166AB146C9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019E2B-FA57-B58C-DA85-FACDE38D7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8352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94D0AF-E17E-151C-EE82-E6F69A5381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EE6578-DA8B-EE9A-84AE-827EC7379F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F4B51F-933B-BF26-83C2-3C0F127D02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3B3783-29CD-7E76-8B07-F52AFCF912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079BBE-A69E-4052-D46A-EFE735E635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54621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678B95-B489-6691-A121-9CC6C4B712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C91E10-CD3D-3EDC-DFB0-803D967D569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333D40-635E-6ABB-1B03-872F3BE745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E6EE93-F983-49B8-E287-350ACD5A55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60D05B-83E8-E736-62CA-978BDAC898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93DB88-7FCA-805B-B25D-A15ED303AD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0588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82B4D2-B742-74AD-7E4F-1C36C8BF38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63AD43-55EA-D2A5-C714-0F0235245F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6B4C5E5-8085-43E6-0982-479004178F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04259B2-C329-5225-AFC6-1C45D9A865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D7D774B-43D2-0E6E-192B-05B59342A2E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7031BED-9BF2-1594-9AF9-A8C3F85743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24B5B88-637B-2382-48A0-432B9BCA7C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796C8DB-709D-927A-830E-6AA222BC3F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1748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449D5E-0BC9-365E-FBD0-5C50E02B17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C96A71A-9EAC-E539-A92E-A8C4A2D890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8358E02-2118-7788-D756-0079827477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331ED9F-AC4C-29FD-4CB8-C8FF1F5E6D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4720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6886813-0D54-97B1-9E59-858D295EA0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62F8018-E02D-A9CE-D719-36E85435A1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890113A-1DA2-D8A0-5CA8-0ED75C8298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49721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43400C-96A9-3332-9F54-0E6371A59D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3E3DF7-C799-1095-64F8-E94B03841B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F4E82F2-DA81-4ABB-2630-6746143C0F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19D5D2-2449-89D1-2373-E4AF24D1C5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9B6FAA-D7A8-C85A-18DA-83379ECCAE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E519064-18BA-1CDB-19AA-2A29554E3F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7188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287BDD-9463-3AED-548E-435A5322B0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F4E64A2-3F6D-03EB-E76D-5046D5A6C01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643AA9C-110C-6439-5410-F3CF4C84BC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390388-7848-4138-531B-EF7F15E218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5C8E1D-B33D-C775-C3DB-16B67AF939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BB3E97-98B0-29A3-9A63-2EA4A8910F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7343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DB1D7BD-CDAC-68DD-C607-2E71AB3D3F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BC608A-12FF-754B-AF73-6DDBDF80C9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5060F9-A318-F7D9-7F7A-431771AB91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FBAE388-B9EC-4E89-8BE9-941DF5ACAA68}" type="datetimeFigureOut">
              <a:rPr lang="en-US" smtClean="0"/>
              <a:t>1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A5AA70-A864-7D31-742F-E7BD4D0D154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91EC38-407C-52B9-1DA8-1E0EBDCB003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1E0767F-0B33-4FE5-AA2E-C640DB6956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9813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Group 35"/>
          <p:cNvGrpSpPr/>
          <p:nvPr/>
        </p:nvGrpSpPr>
        <p:grpSpPr>
          <a:xfrm>
            <a:off x="242365" y="1164892"/>
            <a:ext cx="11384739" cy="4739443"/>
            <a:chOff x="242365" y="922846"/>
            <a:chExt cx="11384739" cy="4739443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070175" y="1325621"/>
              <a:ext cx="3729119" cy="4320598"/>
            </a:xfrm>
            <a:prstGeom prst="rect">
              <a:avLst/>
            </a:prstGeom>
            <a:ln>
              <a:noFill/>
            </a:ln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840064" y="1325621"/>
              <a:ext cx="3616830" cy="4336668"/>
            </a:xfrm>
            <a:prstGeom prst="rect">
              <a:avLst/>
            </a:prstGeom>
            <a:ln>
              <a:noFill/>
            </a:ln>
          </p:spPr>
        </p:pic>
        <p:sp>
          <p:nvSpPr>
            <p:cNvPr id="23" name="TextBox 22"/>
            <p:cNvSpPr txBox="1"/>
            <p:nvPr/>
          </p:nvSpPr>
          <p:spPr>
            <a:xfrm>
              <a:off x="704888" y="977574"/>
              <a:ext cx="92204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Activated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636995" y="977574"/>
              <a:ext cx="114005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Suppressed</a:t>
              </a:r>
            </a:p>
          </p:txBody>
        </p:sp>
        <p:sp>
          <p:nvSpPr>
            <p:cNvPr id="25" name="Left Bracket 24"/>
            <p:cNvSpPr/>
            <p:nvPr/>
          </p:nvSpPr>
          <p:spPr>
            <a:xfrm rot="5400000">
              <a:off x="2031010" y="-732805"/>
              <a:ext cx="267672" cy="3578973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42365" y="1317586"/>
              <a:ext cx="3769889" cy="4336668"/>
            </a:xfrm>
            <a:prstGeom prst="rect">
              <a:avLst/>
            </a:prstGeom>
            <a:ln>
              <a:noFill/>
            </a:ln>
          </p:spPr>
        </p:pic>
        <p:sp>
          <p:nvSpPr>
            <p:cNvPr id="27" name="TextBox 26"/>
            <p:cNvSpPr txBox="1"/>
            <p:nvPr/>
          </p:nvSpPr>
          <p:spPr>
            <a:xfrm>
              <a:off x="4397603" y="999771"/>
              <a:ext cx="92204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Activated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6177852" y="980204"/>
              <a:ext cx="114005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Suppressed</a:t>
              </a:r>
            </a:p>
          </p:txBody>
        </p:sp>
        <p:sp>
          <p:nvSpPr>
            <p:cNvPr id="29" name="Left Bracket 28"/>
            <p:cNvSpPr/>
            <p:nvPr/>
          </p:nvSpPr>
          <p:spPr>
            <a:xfrm rot="5400000">
              <a:off x="5875972" y="-710608"/>
              <a:ext cx="267672" cy="3578973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8216162" y="999771"/>
              <a:ext cx="92204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Activated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10309767" y="999771"/>
              <a:ext cx="114005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Suppressed</a:t>
              </a:r>
            </a:p>
          </p:txBody>
        </p:sp>
        <p:sp>
          <p:nvSpPr>
            <p:cNvPr id="32" name="Left Bracket 31"/>
            <p:cNvSpPr/>
            <p:nvPr/>
          </p:nvSpPr>
          <p:spPr>
            <a:xfrm rot="5400000">
              <a:off x="9703782" y="-710608"/>
              <a:ext cx="267672" cy="3578973"/>
            </a:xfrm>
            <a:prstGeom prst="leftBracket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1816444" y="1017844"/>
              <a:ext cx="434151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3d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5369257" y="1017844"/>
              <a:ext cx="393056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7d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9217944" y="1017844"/>
              <a:ext cx="492443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14d</a:t>
              </a:r>
            </a:p>
          </p:txBody>
        </p:sp>
      </p:grpSp>
      <p:sp>
        <p:nvSpPr>
          <p:cNvPr id="37" name="TextBox 36"/>
          <p:cNvSpPr txBox="1"/>
          <p:nvPr/>
        </p:nvSpPr>
        <p:spPr>
          <a:xfrm>
            <a:off x="1584517" y="5904335"/>
            <a:ext cx="8980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ene Ratio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5036731" y="5896300"/>
            <a:ext cx="8980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ene Ratio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8884697" y="5888265"/>
            <a:ext cx="8980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ene Ratio</a:t>
            </a:r>
          </a:p>
        </p:txBody>
      </p:sp>
      <p:sp>
        <p:nvSpPr>
          <p:cNvPr id="40" name="Rectangle 39"/>
          <p:cNvSpPr/>
          <p:nvPr/>
        </p:nvSpPr>
        <p:spPr>
          <a:xfrm>
            <a:off x="0" y="87868"/>
            <a:ext cx="9156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S8</a:t>
            </a:r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8E79B6C-0E3C-4C22-CB87-44CE1CC1BE72}"/>
              </a:ext>
            </a:extLst>
          </p:cNvPr>
          <p:cNvSpPr txBox="1"/>
          <p:nvPr/>
        </p:nvSpPr>
        <p:spPr>
          <a:xfrm>
            <a:off x="4948021" y="790392"/>
            <a:ext cx="19734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istal Ileum- CFA</a:t>
            </a:r>
          </a:p>
        </p:txBody>
      </p:sp>
    </p:spTree>
    <p:extLst>
      <p:ext uri="{BB962C8B-B14F-4D97-AF65-F5344CB8AC3E}">
        <p14:creationId xmlns:p14="http://schemas.microsoft.com/office/powerpoint/2010/main" val="39270490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21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>Rush University Medical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eghan Moran</dc:creator>
  <cp:lastModifiedBy>Meghan Moran</cp:lastModifiedBy>
  <cp:revision>19</cp:revision>
  <dcterms:created xsi:type="dcterms:W3CDTF">2025-11-21T17:16:35Z</dcterms:created>
  <dcterms:modified xsi:type="dcterms:W3CDTF">2025-11-21T17:30:53Z</dcterms:modified>
</cp:coreProperties>
</file>